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3466D-3071-4780-816C-741FD5A19C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880BF2-F694-434C-BB91-CDDE1DD48A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46170-DE0F-4448-A036-72E07B9571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54B5A-CC34-41C0-A254-EC82DD8C58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578CF-2752-4A4A-8369-95F03E5D5E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ED5A5-77A6-499E-89AD-AED3EB14A9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52E26-5B78-4E5C-A406-E98D43F951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30715-B270-4E1D-BA9D-EF520E2A99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B6A7D-44D7-4277-9D65-475B81E4F0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92E3AB-94AC-429F-856E-1EEEE39E40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7AD7B-BB63-460C-92FC-1D3B8512AD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68C2C-42D9-419C-9551-C9CC777025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AD9BBE-B6A2-4D3B-B51D-797C2A8290D2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2.png"/><Relationship Id="rId5" Type="http://schemas.openxmlformats.org/officeDocument/2006/relationships/image" Target="../media/image4.jpeg"/><Relationship Id="rId6" Type="http://schemas.openxmlformats.org/officeDocument/2006/relationships/image" Target="../media/image2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31"/>
          <p:cNvSpPr/>
          <p:nvPr/>
        </p:nvSpPr>
        <p:spPr>
          <a:xfrm>
            <a:off x="-71280" y="-52560"/>
            <a:ext cx="428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CasellaDiTesto 33"/>
          <p:cNvSpPr/>
          <p:nvPr/>
        </p:nvSpPr>
        <p:spPr>
          <a:xfrm>
            <a:off x="2000160" y="3305160"/>
            <a:ext cx="42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uppo 36"/>
          <p:cNvGrpSpPr/>
          <p:nvPr/>
        </p:nvGrpSpPr>
        <p:grpSpPr>
          <a:xfrm>
            <a:off x="0" y="-22320"/>
            <a:ext cx="9429840" cy="6880320"/>
            <a:chOff x="0" y="-22320"/>
            <a:chExt cx="9429840" cy="6880320"/>
          </a:xfrm>
        </p:grpSpPr>
        <p:grpSp>
          <p:nvGrpSpPr>
            <p:cNvPr id="44" name="Gruppo 40"/>
            <p:cNvGrpSpPr/>
            <p:nvPr/>
          </p:nvGrpSpPr>
          <p:grpSpPr>
            <a:xfrm>
              <a:off x="0" y="-22320"/>
              <a:ext cx="9429840" cy="6880320"/>
              <a:chOff x="0" y="-22320"/>
              <a:chExt cx="9429840" cy="6880320"/>
            </a:xfrm>
          </p:grpSpPr>
          <p:grpSp>
            <p:nvGrpSpPr>
              <p:cNvPr id="45" name="Gruppo 23"/>
              <p:cNvGrpSpPr/>
              <p:nvPr/>
            </p:nvGrpSpPr>
            <p:grpSpPr>
              <a:xfrm>
                <a:off x="0" y="-22320"/>
                <a:ext cx="4500720" cy="3042360"/>
                <a:chOff x="0" y="-22320"/>
                <a:chExt cx="4500720" cy="3042360"/>
              </a:xfrm>
            </p:grpSpPr>
            <p:pic>
              <p:nvPicPr>
                <p:cNvPr id="46" name="Picture 3" descr="C:\Users\User\Desktop\Revisione earlyART_2\Prevalence of puffy fingers_EULAR_ACR selection.jpg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0" y="0"/>
                  <a:ext cx="4358160" cy="3020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7" name="CasellaDiTesto 11"/>
                <p:cNvSpPr/>
                <p:nvPr/>
              </p:nvSpPr>
              <p:spPr>
                <a:xfrm>
                  <a:off x="1285920" y="0"/>
                  <a:ext cx="23576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600" spc="-1" strike="noStrike">
                      <a:solidFill>
                        <a:srgbClr val="000000"/>
                      </a:solidFill>
                      <a:latin typeface="Calibri"/>
                    </a:rPr>
                    <a:t>Puffy fingers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48" name="Picture 8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3346560" y="23040"/>
                  <a:ext cx="368280" cy="4777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9" name="CasellaDiTesto 16"/>
                <p:cNvSpPr/>
                <p:nvPr/>
              </p:nvSpPr>
              <p:spPr>
                <a:xfrm>
                  <a:off x="3714840" y="-22320"/>
                  <a:ext cx="500040" cy="52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yes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no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CasellaDiTesto 29"/>
                <p:cNvSpPr/>
                <p:nvPr/>
              </p:nvSpPr>
              <p:spPr>
                <a:xfrm>
                  <a:off x="3143520" y="477720"/>
                  <a:ext cx="13572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p = 0.0001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CasellaDiTesto 30"/>
                <p:cNvSpPr/>
                <p:nvPr/>
              </p:nvSpPr>
              <p:spPr>
                <a:xfrm>
                  <a:off x="2643480" y="365400"/>
                  <a:ext cx="7142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2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CasellaDiTesto 31"/>
                <p:cNvSpPr/>
                <p:nvPr/>
              </p:nvSpPr>
              <p:spPr>
                <a:xfrm>
                  <a:off x="3500640" y="2071440"/>
                  <a:ext cx="5713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CasellaDiTesto 35"/>
                <p:cNvSpPr/>
                <p:nvPr/>
              </p:nvSpPr>
              <p:spPr>
                <a:xfrm>
                  <a:off x="1571760" y="937800"/>
                  <a:ext cx="642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1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CasellaDiTesto 34"/>
                <p:cNvSpPr/>
                <p:nvPr/>
              </p:nvSpPr>
              <p:spPr>
                <a:xfrm>
                  <a:off x="928440" y="2143080"/>
                  <a:ext cx="500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" name="Gruppo 35"/>
              <p:cNvGrpSpPr/>
              <p:nvPr/>
            </p:nvGrpSpPr>
            <p:grpSpPr>
              <a:xfrm>
                <a:off x="2000160" y="3357360"/>
                <a:ext cx="5143680" cy="3500640"/>
                <a:chOff x="2000160" y="3357360"/>
                <a:chExt cx="5143680" cy="3500640"/>
              </a:xfrm>
            </p:grpSpPr>
            <p:pic>
              <p:nvPicPr>
                <p:cNvPr id="56" name="Picture 5" descr="C:\Users\User\Desktop\Revisione earlyART_2\Prevalence of NVC abnormalities_EULAR_ACR selection.jpg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2000160" y="3394080"/>
                  <a:ext cx="5143680" cy="3463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7" name="CasellaDiTesto 22"/>
                <p:cNvSpPr/>
                <p:nvPr/>
              </p:nvSpPr>
              <p:spPr>
                <a:xfrm>
                  <a:off x="3214440" y="3357360"/>
                  <a:ext cx="27147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600" spc="-1" strike="noStrike">
                      <a:solidFill>
                        <a:srgbClr val="000000"/>
                      </a:solidFill>
                      <a:latin typeface="Calibri"/>
                    </a:rPr>
                    <a:t>NVC scleroderma patter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58" name="Picture 8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6000840" y="3429000"/>
                  <a:ext cx="368280" cy="4777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9" name="CasellaDiTesto 25"/>
                <p:cNvSpPr/>
                <p:nvPr/>
              </p:nvSpPr>
              <p:spPr>
                <a:xfrm>
                  <a:off x="6369120" y="3383280"/>
                  <a:ext cx="500040" cy="52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yes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no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CasellaDiTesto 26"/>
                <p:cNvSpPr/>
                <p:nvPr/>
              </p:nvSpPr>
              <p:spPr>
                <a:xfrm>
                  <a:off x="5786640" y="3928680"/>
                  <a:ext cx="13572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p = 0.033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CasellaDiTesto 41"/>
                <p:cNvSpPr/>
                <p:nvPr/>
              </p:nvSpPr>
              <p:spPr>
                <a:xfrm>
                  <a:off x="3071520" y="4152600"/>
                  <a:ext cx="5713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2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CasellaDiTesto 42"/>
                <p:cNvSpPr/>
                <p:nvPr/>
              </p:nvSpPr>
              <p:spPr>
                <a:xfrm>
                  <a:off x="3929040" y="5929200"/>
                  <a:ext cx="500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CasellaDiTesto 43"/>
                <p:cNvSpPr/>
                <p:nvPr/>
              </p:nvSpPr>
              <p:spPr>
                <a:xfrm>
                  <a:off x="5214960" y="3714480"/>
                  <a:ext cx="642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2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CasellaDiTesto 44"/>
                <p:cNvSpPr/>
                <p:nvPr/>
              </p:nvSpPr>
              <p:spPr>
                <a:xfrm>
                  <a:off x="6000840" y="4786200"/>
                  <a:ext cx="642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1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5" name="Gruppo 39"/>
              <p:cNvGrpSpPr/>
              <p:nvPr/>
            </p:nvGrpSpPr>
            <p:grpSpPr>
              <a:xfrm>
                <a:off x="4143240" y="-360"/>
                <a:ext cx="5286600" cy="2972520"/>
                <a:chOff x="4143240" y="-360"/>
                <a:chExt cx="5286600" cy="2972520"/>
              </a:xfrm>
            </p:grpSpPr>
            <p:pic>
              <p:nvPicPr>
                <p:cNvPr id="66" name="Picture 36" descr="C:\Users\User\Desktop\Revisione earlyART_2\Prevalence of arthritis_EULAR_ACR criteria.jpg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4285800" y="-360"/>
                  <a:ext cx="4358160" cy="2972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7" name="CasellaDiTesto 32"/>
                <p:cNvSpPr/>
                <p:nvPr/>
              </p:nvSpPr>
              <p:spPr>
                <a:xfrm>
                  <a:off x="4143240" y="18000"/>
                  <a:ext cx="4284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6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CasellaDiTesto 40"/>
                <p:cNvSpPr/>
                <p:nvPr/>
              </p:nvSpPr>
              <p:spPr>
                <a:xfrm>
                  <a:off x="7500960" y="2152440"/>
                  <a:ext cx="500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CasellaDiTesto 38"/>
                <p:cNvSpPr/>
                <p:nvPr/>
              </p:nvSpPr>
              <p:spPr>
                <a:xfrm>
                  <a:off x="6643800" y="794160"/>
                  <a:ext cx="642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1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CasellaDiTesto 39"/>
                <p:cNvSpPr/>
                <p:nvPr/>
              </p:nvSpPr>
              <p:spPr>
                <a:xfrm>
                  <a:off x="7786800" y="294120"/>
                  <a:ext cx="7858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Calibri"/>
                    </a:rPr>
                    <a:t>n=2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71" name="Picture 8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8347320" y="71280"/>
                  <a:ext cx="368280" cy="4777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2" name="CasellaDiTesto 17"/>
                <p:cNvSpPr/>
                <p:nvPr/>
              </p:nvSpPr>
              <p:spPr>
                <a:xfrm>
                  <a:off x="8715600" y="25920"/>
                  <a:ext cx="500040" cy="52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yes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no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CasellaDiTesto 27"/>
                <p:cNvSpPr/>
                <p:nvPr/>
              </p:nvSpPr>
              <p:spPr>
                <a:xfrm>
                  <a:off x="8072640" y="549360"/>
                  <a:ext cx="13572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400" spc="-1" strike="noStrike">
                      <a:solidFill>
                        <a:srgbClr val="000000"/>
                      </a:solidFill>
                      <a:latin typeface="Calibri"/>
                    </a:rPr>
                    <a:t>p &gt; 0.05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CasellaDiTesto 12"/>
                <p:cNvSpPr/>
                <p:nvPr/>
              </p:nvSpPr>
              <p:spPr>
                <a:xfrm>
                  <a:off x="5715000" y="-360"/>
                  <a:ext cx="23576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600" spc="-1" strike="noStrike">
                      <a:solidFill>
                        <a:srgbClr val="000000"/>
                      </a:solidFill>
                      <a:latin typeface="Calibri"/>
                    </a:rPr>
                    <a:t>Arthritis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CasellaDiTesto 37"/>
                <p:cNvSpPr/>
                <p:nvPr/>
              </p:nvSpPr>
              <p:spPr>
                <a:xfrm>
                  <a:off x="5357520" y="222480"/>
                  <a:ext cx="642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 u="sng">
                      <a:solidFill>
                        <a:srgbClr val="000000"/>
                      </a:solidFill>
                      <a:uFillTx/>
                      <a:latin typeface="Arial"/>
                    </a:rPr>
                    <a:t>n=2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6" name="CasellaDiTesto 35"/>
            <p:cNvSpPr/>
            <p:nvPr/>
          </p:nvSpPr>
          <p:spPr>
            <a:xfrm>
              <a:off x="35280" y="6381360"/>
              <a:ext cx="93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</a:rPr>
                <a:t>Figure 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9T13:46:41Z</dcterms:created>
  <dc:creator>User</dc:creator>
  <dc:description/>
  <dc:language>en-US</dc:language>
  <cp:lastModifiedBy>cesare</cp:lastModifiedBy>
  <dcterms:modified xsi:type="dcterms:W3CDTF">2013-05-16T19:50:43Z</dcterms:modified>
  <cp:revision>8</cp:revision>
  <dc:subject/>
  <dc:title>Diapositiva 1</dc:title>
</cp:coreProperties>
</file>